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D4B57AB8-9AA6-49E3-B502-D20D87341209}"/>
    <pc:docChg chg="undo custSel addSld delSld modSld">
      <pc:chgData name="Mohan, Man" userId="37104710-05df-4370-9d86-514a293a6e2e" providerId="ADAL" clId="{D4B57AB8-9AA6-49E3-B502-D20D87341209}" dt="2024-10-11T13:53:58.415" v="72" actId="1076"/>
      <pc:docMkLst>
        <pc:docMk/>
      </pc:docMkLst>
      <pc:sldChg chg="del">
        <pc:chgData name="Mohan, Man" userId="37104710-05df-4370-9d86-514a293a6e2e" providerId="ADAL" clId="{D4B57AB8-9AA6-49E3-B502-D20D87341209}" dt="2024-10-11T02:41:20.998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D4B57AB8-9AA6-49E3-B502-D20D87341209}" dt="2024-10-11T02:41:21.453" v="1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D4B57AB8-9AA6-49E3-B502-D20D87341209}" dt="2024-10-11T02:41:21.877" v="2" actId="47"/>
        <pc:sldMkLst>
          <pc:docMk/>
          <pc:sldMk cId="3414948269" sldId="258"/>
        </pc:sldMkLst>
      </pc:sldChg>
      <pc:sldChg chg="addSp modSp mod">
        <pc:chgData name="Mohan, Man" userId="37104710-05df-4370-9d86-514a293a6e2e" providerId="ADAL" clId="{D4B57AB8-9AA6-49E3-B502-D20D87341209}" dt="2024-10-11T13:53:58.415" v="72" actId="1076"/>
        <pc:sldMkLst>
          <pc:docMk/>
          <pc:sldMk cId="3742170954" sldId="259"/>
        </pc:sldMkLst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2" creationId="{35BB8387-BCB2-00D7-5C5B-15B42BB7F418}"/>
          </ac:spMkLst>
        </pc:spChg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4" creationId="{E26CDE51-7AD4-8681-2B74-8BCC8C7789E9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8" creationId="{5FB2BB8F-1B53-4AF8-B16E-94B4ADB6724D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9" creationId="{A06013B7-A442-487F-8CDD-DCD295D4BB7A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0" creationId="{22FD2472-B3F5-4B38-813F-F76EE62E5C86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1" creationId="{89D05585-24B5-40FA-839D-E8E3D3C129DC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2" creationId="{063F8DDE-AFDA-4553-8C53-96652233F30D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3" creationId="{5B01E50D-7018-46D9-B3CA-2EBF6309B5C7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4" creationId="{9A47944A-F843-4530-ACAE-29370E0A24E5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5" creationId="{7C83597D-C394-4DD6-8A30-28B6F0C72C7C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16" creationId="{2C10DB24-F38B-436F-B0F1-FD7914404625}"/>
          </ac:spMkLst>
        </pc:spChg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20" creationId="{A0A83262-D2FD-7AD5-D64B-99A624FA8E9F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1" creationId="{A42EAC92-E3E1-4CA4-9C3C-CE2799928ACC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2" creationId="{A45051AF-434C-425C-9640-FC8E89424577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3" creationId="{FE7C438F-D03C-4288-ACE8-3ED3405F901D}"/>
          </ac:spMkLst>
        </pc:spChg>
        <pc:spChg chg="mod">
          <ac:chgData name="Mohan, Man" userId="37104710-05df-4370-9d86-514a293a6e2e" providerId="ADAL" clId="{D4B57AB8-9AA6-49E3-B502-D20D87341209}" dt="2024-10-11T13:53:58.415" v="72" actId="1076"/>
          <ac:spMkLst>
            <pc:docMk/>
            <pc:sldMk cId="3742170954" sldId="259"/>
            <ac:spMk id="24" creationId="{B40AF23D-5444-4D34-85C5-DE88873F0C33}"/>
          </ac:spMkLst>
        </pc:spChg>
        <pc:spChg chg="mod">
          <ac:chgData name="Mohan, Man" userId="37104710-05df-4370-9d86-514a293a6e2e" providerId="ADAL" clId="{D4B57AB8-9AA6-49E3-B502-D20D87341209}" dt="2024-10-11T13:53:38.647" v="66" actId="164"/>
          <ac:spMkLst>
            <pc:docMk/>
            <pc:sldMk cId="3742170954" sldId="259"/>
            <ac:spMk id="35" creationId="{01717834-3B66-43B1-9E07-DCF9BECC1ADC}"/>
          </ac:spMkLst>
        </pc:spChg>
        <pc:grpChg chg="add mod">
          <ac:chgData name="Mohan, Man" userId="37104710-05df-4370-9d86-514a293a6e2e" providerId="ADAL" clId="{D4B57AB8-9AA6-49E3-B502-D20D87341209}" dt="2024-10-11T13:53:56.533" v="71" actId="1076"/>
          <ac:grpSpMkLst>
            <pc:docMk/>
            <pc:sldMk cId="3742170954" sldId="259"/>
            <ac:grpSpMk id="3" creationId="{34530218-6380-0156-3E1D-CA99A867D904}"/>
          </ac:grpSpMkLst>
        </pc:grpChg>
        <pc:grpChg chg="add mod">
          <ac:chgData name="Mohan, Man" userId="37104710-05df-4370-9d86-514a293a6e2e" providerId="ADAL" clId="{D4B57AB8-9AA6-49E3-B502-D20D87341209}" dt="2024-10-11T13:53:58.415" v="72" actId="1076"/>
          <ac:grpSpMkLst>
            <pc:docMk/>
            <pc:sldMk cId="3742170954" sldId="259"/>
            <ac:grpSpMk id="6" creationId="{AF6BF1D1-7AEC-1797-452F-E919557DE7EC}"/>
          </ac:grpSpMkLst>
        </pc:grp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26" creationId="{F71060F7-1335-411A-80DE-C306A50DEBBA}"/>
          </ac:picMkLst>
        </pc:pic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28" creationId="{F3C0D467-0DD0-4852-A9E7-98F055CD9564}"/>
          </ac:picMkLst>
        </pc:pic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30" creationId="{B4E030FD-77AE-4224-B921-72CE78502D48}"/>
          </ac:picMkLst>
        </pc:picChg>
        <pc:picChg chg="mod">
          <ac:chgData name="Mohan, Man" userId="37104710-05df-4370-9d86-514a293a6e2e" providerId="ADAL" clId="{D4B57AB8-9AA6-49E3-B502-D20D87341209}" dt="2024-10-11T13:53:58.415" v="72" actId="1076"/>
          <ac:picMkLst>
            <pc:docMk/>
            <pc:sldMk cId="3742170954" sldId="259"/>
            <ac:picMk id="32" creationId="{AA024D7A-23F6-455A-88EA-9C8B996216A5}"/>
          </ac:picMkLst>
        </pc:picChg>
        <pc:picChg chg="mod">
          <ac:chgData name="Mohan, Man" userId="37104710-05df-4370-9d86-514a293a6e2e" providerId="ADAL" clId="{D4B57AB8-9AA6-49E3-B502-D20D87341209}" dt="2024-10-11T13:53:38.647" v="66" actId="164"/>
          <ac:picMkLst>
            <pc:docMk/>
            <pc:sldMk cId="3742170954" sldId="259"/>
            <ac:picMk id="34" creationId="{D48D7F8D-CE7E-4BF4-8689-2355D6DDA299}"/>
          </ac:picMkLst>
        </pc:picChg>
        <pc:cxnChg chg="mod">
          <ac:chgData name="Mohan, Man" userId="37104710-05df-4370-9d86-514a293a6e2e" providerId="ADAL" clId="{D4B57AB8-9AA6-49E3-B502-D20D87341209}" dt="2024-10-11T13:53:58.415" v="72" actId="1076"/>
          <ac:cxnSpMkLst>
            <pc:docMk/>
            <pc:sldMk cId="3742170954" sldId="259"/>
            <ac:cxnSpMk id="17" creationId="{DA605F68-8286-477F-9CD1-ABFF8F4D6B88}"/>
          </ac:cxnSpMkLst>
        </pc:cxnChg>
        <pc:cxnChg chg="mod">
          <ac:chgData name="Mohan, Man" userId="37104710-05df-4370-9d86-514a293a6e2e" providerId="ADAL" clId="{D4B57AB8-9AA6-49E3-B502-D20D87341209}" dt="2024-10-11T13:53:58.415" v="72" actId="1076"/>
          <ac:cxnSpMkLst>
            <pc:docMk/>
            <pc:sldMk cId="3742170954" sldId="259"/>
            <ac:cxnSpMk id="18" creationId="{05C0F87A-CD05-4F19-B9FB-1464AFC80CC6}"/>
          </ac:cxnSpMkLst>
        </pc:cxnChg>
        <pc:cxnChg chg="mod">
          <ac:chgData name="Mohan, Man" userId="37104710-05df-4370-9d86-514a293a6e2e" providerId="ADAL" clId="{D4B57AB8-9AA6-49E3-B502-D20D87341209}" dt="2024-10-11T13:53:58.415" v="72" actId="1076"/>
          <ac:cxnSpMkLst>
            <pc:docMk/>
            <pc:sldMk cId="3742170954" sldId="259"/>
            <ac:cxnSpMk id="19" creationId="{A41C07D8-E0B0-4BA8-8505-22135779E171}"/>
          </ac:cxnSpMkLst>
        </pc:cxnChg>
      </pc:sldChg>
      <pc:sldChg chg="del">
        <pc:chgData name="Mohan, Man" userId="37104710-05df-4370-9d86-514a293a6e2e" providerId="ADAL" clId="{D4B57AB8-9AA6-49E3-B502-D20D87341209}" dt="2024-10-11T02:42:03.648" v="23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D4B57AB8-9AA6-49E3-B502-D20D87341209}" dt="2024-10-11T02:42:04.277" v="24" actId="47"/>
        <pc:sldMkLst>
          <pc:docMk/>
          <pc:sldMk cId="2717183306" sldId="262"/>
        </pc:sldMkLst>
      </pc:sldChg>
      <pc:sldChg chg="del">
        <pc:chgData name="Mohan, Man" userId="37104710-05df-4370-9d86-514a293a6e2e" providerId="ADAL" clId="{D4B57AB8-9AA6-49E3-B502-D20D87341209}" dt="2024-10-11T02:42:07.023" v="25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D4B57AB8-9AA6-49E3-B502-D20D87341209}" dt="2024-10-11T02:42:00.239" v="21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D4B57AB8-9AA6-49E3-B502-D20D87341209}" dt="2024-10-11T02:42:00.915" v="22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D4B57AB8-9AA6-49E3-B502-D20D87341209}" dt="2024-10-11T02:41:32.994" v="3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D4B57AB8-9AA6-49E3-B502-D20D87341209}" dt="2024-10-11T02:41:33.827" v="4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D4B57AB8-9AA6-49E3-B502-D20D87341209}" dt="2024-10-11T02:41:35.617" v="6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D4B57AB8-9AA6-49E3-B502-D20D87341209}" dt="2024-10-11T02:41:34.722" v="5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D4B57AB8-9AA6-49E3-B502-D20D87341209}" dt="2024-10-11T02:41:36.481" v="7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D4B57AB8-9AA6-49E3-B502-D20D87341209}" dt="2024-10-11T02:41:37.375" v="8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D4B57AB8-9AA6-49E3-B502-D20D87341209}" dt="2024-10-11T02:41:38.256" v="9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D4B57AB8-9AA6-49E3-B502-D20D87341209}" dt="2024-10-11T02:41:39.133" v="10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D4B57AB8-9AA6-49E3-B502-D20D87341209}" dt="2024-10-11T02:41:39.950" v="11" actId="47"/>
        <pc:sldMkLst>
          <pc:docMk/>
          <pc:sldMk cId="3635091487" sldId="275"/>
        </pc:sldMkLst>
      </pc:sldChg>
      <pc:sldChg chg="addSp delSp modSp mod">
        <pc:chgData name="Mohan, Man" userId="37104710-05df-4370-9d86-514a293a6e2e" providerId="ADAL" clId="{D4B57AB8-9AA6-49E3-B502-D20D87341209}" dt="2024-10-11T02:49:53.117" v="64" actId="14100"/>
        <pc:sldMkLst>
          <pc:docMk/>
          <pc:sldMk cId="285705100" sldId="282"/>
        </pc:sldMkLst>
        <pc:spChg chg="mod">
          <ac:chgData name="Mohan, Man" userId="37104710-05df-4370-9d86-514a293a6e2e" providerId="ADAL" clId="{D4B57AB8-9AA6-49E3-B502-D20D87341209}" dt="2024-10-11T02:46:03.154" v="30" actId="207"/>
          <ac:spMkLst>
            <pc:docMk/>
            <pc:sldMk cId="285705100" sldId="282"/>
            <ac:spMk id="5" creationId="{EEB0813F-470F-7BED-7208-2F8F0EB61B9F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6" creationId="{298200D3-E3A4-C678-2F35-4DC7C2C878E5}"/>
          </ac:spMkLst>
        </pc:spChg>
        <pc:spChg chg="mod">
          <ac:chgData name="Mohan, Man" userId="37104710-05df-4370-9d86-514a293a6e2e" providerId="ADAL" clId="{D4B57AB8-9AA6-49E3-B502-D20D87341209}" dt="2024-10-11T02:49:36.188" v="49" actId="20577"/>
          <ac:spMkLst>
            <pc:docMk/>
            <pc:sldMk cId="285705100" sldId="282"/>
            <ac:spMk id="9" creationId="{EA1AC91D-6689-6610-EB40-DF93AF40A1A6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0" creationId="{767F67BD-2C9A-97E3-CE77-A07EF761662B}"/>
          </ac:spMkLst>
        </pc:spChg>
        <pc:spChg chg="mod">
          <ac:chgData name="Mohan, Man" userId="37104710-05df-4370-9d86-514a293a6e2e" providerId="ADAL" clId="{D4B57AB8-9AA6-49E3-B502-D20D87341209}" dt="2024-10-11T02:49:53.117" v="64" actId="14100"/>
          <ac:spMkLst>
            <pc:docMk/>
            <pc:sldMk cId="285705100" sldId="282"/>
            <ac:spMk id="11" creationId="{A046E86D-676E-DD76-84BD-44958E7337FF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2" creationId="{1A27DD53-EC9C-6CA9-496E-D84A3A5DED21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3" creationId="{80BCCEDB-3B85-FB6D-1259-764AD0250FC6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4" creationId="{139B6BAD-3F84-4A49-16F0-FB8A1D826F9E}"/>
          </ac:spMkLst>
        </pc:spChg>
        <pc:spChg chg="mod">
          <ac:chgData name="Mohan, Man" userId="37104710-05df-4370-9d86-514a293a6e2e" providerId="ADAL" clId="{D4B57AB8-9AA6-49E3-B502-D20D87341209}" dt="2024-10-11T02:45:38.903" v="26"/>
          <ac:spMkLst>
            <pc:docMk/>
            <pc:sldMk cId="285705100" sldId="282"/>
            <ac:spMk id="15" creationId="{4B015359-C663-2FE1-2F15-8F8DEE816261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25" creationId="{363A6695-EF85-D109-394C-A459B383F3C0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26" creationId="{78863437-56C6-6438-7672-9BF1844C1EA2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0" creationId="{2A56398A-29F3-D46A-4974-368CDF59B204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3" creationId="{0934D3BB-4DCD-BB34-114F-CD4F061D5D66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4" creationId="{CC42CDED-0D3E-17CC-8B25-65BAF457EC2A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5" creationId="{A5D02F92-B1B9-B7D1-AF24-CF961971B4BB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7" creationId="{A22B2A63-54B4-62D6-6D0F-245EE9C1918E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39" creationId="{FD868CD1-0826-92CE-C8D7-5152AB36E458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41" creationId="{0D104BA0-BC11-1745-6F0D-713A5232B5EA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47" creationId="{5CC12EA6-FAB8-570E-4041-354909EBA691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48" creationId="{77C8E70C-8C8C-43C9-8AC9-541B36BCA822}"/>
          </ac:spMkLst>
        </pc:spChg>
        <pc:spChg chg="mod">
          <ac:chgData name="Mohan, Man" userId="37104710-05df-4370-9d86-514a293a6e2e" providerId="ADAL" clId="{D4B57AB8-9AA6-49E3-B502-D20D87341209}" dt="2024-10-11T02:49:05.931" v="34" actId="1076"/>
          <ac:spMkLst>
            <pc:docMk/>
            <pc:sldMk cId="285705100" sldId="282"/>
            <ac:spMk id="51" creationId="{007FFAC5-1ADF-698F-AC26-3FD88668AFC9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55" creationId="{C7A140F3-54C1-76D5-B3E6-070B7F7CEDF8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57" creationId="{08F79DC6-354F-B649-CB0A-900F8D99A22B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59" creationId="{52174ABF-E141-3CD1-6088-BF5734C40AC9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1" creationId="{0C5251CC-C846-A4B6-6173-CFBEF22E07D3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2" creationId="{E631403D-044A-4933-0EAC-25BDD2DCCAD8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3" creationId="{4E13FF04-FB9F-B721-8254-23F19BC4BA0B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4" creationId="{8B32013C-9EAD-9691-B423-6616C6CF6A9A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6" creationId="{0C9A5383-57ED-8FFB-C0F8-83461F053254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7" creationId="{A5B9524A-FD9B-B3AB-E675-A2865E4EB1BA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8" creationId="{5A84A983-4DCC-439E-1223-46F6DC67CD9F}"/>
          </ac:spMkLst>
        </pc:spChg>
        <pc:spChg chg="mod">
          <ac:chgData name="Mohan, Man" userId="37104710-05df-4370-9d86-514a293a6e2e" providerId="ADAL" clId="{D4B57AB8-9AA6-49E3-B502-D20D87341209}" dt="2024-10-11T02:45:45.189" v="28" actId="1076"/>
          <ac:spMkLst>
            <pc:docMk/>
            <pc:sldMk cId="285705100" sldId="282"/>
            <ac:spMk id="69" creationId="{EC45A015-494C-26D2-897E-5F50D56E0451}"/>
          </ac:spMkLst>
        </pc:spChg>
        <pc:grpChg chg="add mod">
          <ac:chgData name="Mohan, Man" userId="37104710-05df-4370-9d86-514a293a6e2e" providerId="ADAL" clId="{D4B57AB8-9AA6-49E3-B502-D20D87341209}" dt="2024-10-11T02:49:10.597" v="35" actId="1076"/>
          <ac:grpSpMkLst>
            <pc:docMk/>
            <pc:sldMk cId="285705100" sldId="282"/>
            <ac:grpSpMk id="3" creationId="{C62905AC-386B-E184-4150-5F72AF482BBC}"/>
          </ac:grpSpMkLst>
        </pc:grpChg>
        <pc:grpChg chg="mod">
          <ac:chgData name="Mohan, Man" userId="37104710-05df-4370-9d86-514a293a6e2e" providerId="ADAL" clId="{D4B57AB8-9AA6-49E3-B502-D20D87341209}" dt="2024-10-11T02:45:38.903" v="26"/>
          <ac:grpSpMkLst>
            <pc:docMk/>
            <pc:sldMk cId="285705100" sldId="282"/>
            <ac:grpSpMk id="4" creationId="{B331B232-A3B9-093B-BE00-F6CCE45E7325}"/>
          </ac:grpSpMkLst>
        </pc:grpChg>
        <pc:grpChg chg="add mod">
          <ac:chgData name="Mohan, Man" userId="37104710-05df-4370-9d86-514a293a6e2e" providerId="ADAL" clId="{D4B57AB8-9AA6-49E3-B502-D20D87341209}" dt="2024-10-11T02:49:05.931" v="34" actId="1076"/>
          <ac:grpSpMkLst>
            <pc:docMk/>
            <pc:sldMk cId="285705100" sldId="282"/>
            <ac:grpSpMk id="18" creationId="{08835E2A-99AD-71C4-36A7-21DE87BF51C6}"/>
          </ac:grpSpMkLst>
        </pc:grpChg>
        <pc:grpChg chg="del mod">
          <ac:chgData name="Mohan, Man" userId="37104710-05df-4370-9d86-514a293a6e2e" providerId="ADAL" clId="{D4B57AB8-9AA6-49E3-B502-D20D87341209}" dt="2024-10-11T02:48:59.393" v="33" actId="478"/>
          <ac:grpSpMkLst>
            <pc:docMk/>
            <pc:sldMk cId="285705100" sldId="282"/>
            <ac:grpSpMk id="54" creationId="{70FD6C00-7EA9-FD64-6938-E4CB5A5ED545}"/>
          </ac:grpSpMkLst>
        </pc:grpChg>
        <pc:picChg chg="mod">
          <ac:chgData name="Mohan, Man" userId="37104710-05df-4370-9d86-514a293a6e2e" providerId="ADAL" clId="{D4B57AB8-9AA6-49E3-B502-D20D87341209}" dt="2024-10-11T02:45:38.903" v="26"/>
          <ac:picMkLst>
            <pc:docMk/>
            <pc:sldMk cId="285705100" sldId="282"/>
            <ac:picMk id="8" creationId="{3EC8F080-BACC-60DA-B616-7CB6FFA5ADFE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19" creationId="{61074FAC-B360-EEBC-DF46-3BF9E4A7F437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21" creationId="{B1FE1E03-00E9-F902-EB1E-489E9C87E43E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28" creationId="{92C3F3CC-55A4-EFF9-A4F3-8C768DF91DCE}"/>
          </ac:picMkLst>
        </pc:picChg>
        <pc:picChg chg="mod">
          <ac:chgData name="Mohan, Man" userId="37104710-05df-4370-9d86-514a293a6e2e" providerId="ADAL" clId="{D4B57AB8-9AA6-49E3-B502-D20D87341209}" dt="2024-10-11T02:49:05.931" v="34" actId="1076"/>
          <ac:picMkLst>
            <pc:docMk/>
            <pc:sldMk cId="285705100" sldId="282"/>
            <ac:picMk id="32" creationId="{C20E01DA-AA2E-8755-17EF-6E617DA56118}"/>
          </ac:picMkLst>
        </pc:picChg>
        <pc:picChg chg="mod">
          <ac:chgData name="Mohan, Man" userId="37104710-05df-4370-9d86-514a293a6e2e" providerId="ADAL" clId="{D4B57AB8-9AA6-49E3-B502-D20D87341209}" dt="2024-10-11T02:45:45.189" v="28" actId="1076"/>
          <ac:picMkLst>
            <pc:docMk/>
            <pc:sldMk cId="285705100" sldId="282"/>
            <ac:picMk id="56" creationId="{38D29824-D325-F5B3-BBBE-81E9B5848816}"/>
          </ac:picMkLst>
        </pc:picChg>
        <pc:picChg chg="mod">
          <ac:chgData name="Mohan, Man" userId="37104710-05df-4370-9d86-514a293a6e2e" providerId="ADAL" clId="{D4B57AB8-9AA6-49E3-B502-D20D87341209}" dt="2024-10-11T02:45:45.189" v="28" actId="1076"/>
          <ac:picMkLst>
            <pc:docMk/>
            <pc:sldMk cId="285705100" sldId="282"/>
            <ac:picMk id="58" creationId="{4359CE5D-3C98-9C59-9D4F-FAF71171ED4F}"/>
          </ac:picMkLst>
        </pc:picChg>
        <pc:picChg chg="mod">
          <ac:chgData name="Mohan, Man" userId="37104710-05df-4370-9d86-514a293a6e2e" providerId="ADAL" clId="{D4B57AB8-9AA6-49E3-B502-D20D87341209}" dt="2024-10-11T02:45:45.189" v="28" actId="1076"/>
          <ac:picMkLst>
            <pc:docMk/>
            <pc:sldMk cId="285705100" sldId="282"/>
            <ac:picMk id="60" creationId="{CD9B97FA-ACF5-FFBD-5D34-4CC2627B4B3B}"/>
          </ac:picMkLst>
        </pc:picChg>
        <pc:cxnChg chg="mod">
          <ac:chgData name="Mohan, Man" userId="37104710-05df-4370-9d86-514a293a6e2e" providerId="ADAL" clId="{D4B57AB8-9AA6-49E3-B502-D20D87341209}" dt="2024-10-11T02:45:38.903" v="26"/>
          <ac:cxnSpMkLst>
            <pc:docMk/>
            <pc:sldMk cId="285705100" sldId="282"/>
            <ac:cxnSpMk id="7" creationId="{1AD94848-567E-6FFE-1306-846DEF0E3059}"/>
          </ac:cxnSpMkLst>
        </pc:cxnChg>
        <pc:cxnChg chg="mod">
          <ac:chgData name="Mohan, Man" userId="37104710-05df-4370-9d86-514a293a6e2e" providerId="ADAL" clId="{D4B57AB8-9AA6-49E3-B502-D20D87341209}" dt="2024-10-11T02:45:38.903" v="26"/>
          <ac:cxnSpMkLst>
            <pc:docMk/>
            <pc:sldMk cId="285705100" sldId="282"/>
            <ac:cxnSpMk id="17" creationId="{4FC24FE0-AA5D-D273-98D3-EF46863D24F2}"/>
          </ac:cxnSpMkLst>
        </pc:cxnChg>
        <pc:cxnChg chg="mod">
          <ac:chgData name="Mohan, Man" userId="37104710-05df-4370-9d86-514a293a6e2e" providerId="ADAL" clId="{D4B57AB8-9AA6-49E3-B502-D20D87341209}" dt="2024-10-11T02:49:05.931" v="34" actId="1076"/>
          <ac:cxnSpMkLst>
            <pc:docMk/>
            <pc:sldMk cId="285705100" sldId="282"/>
            <ac:cxnSpMk id="38" creationId="{125E3F26-70B3-D05A-F3EB-0223DC48CD09}"/>
          </ac:cxnSpMkLst>
        </pc:cxnChg>
        <pc:cxnChg chg="mod">
          <ac:chgData name="Mohan, Man" userId="37104710-05df-4370-9d86-514a293a6e2e" providerId="ADAL" clId="{D4B57AB8-9AA6-49E3-B502-D20D87341209}" dt="2024-10-11T02:49:05.931" v="34" actId="1076"/>
          <ac:cxnSpMkLst>
            <pc:docMk/>
            <pc:sldMk cId="285705100" sldId="282"/>
            <ac:cxnSpMk id="49" creationId="{B001C3F8-3AF9-4101-85D5-FF6108143231}"/>
          </ac:cxnSpMkLst>
        </pc:cxnChg>
        <pc:cxnChg chg="mod">
          <ac:chgData name="Mohan, Man" userId="37104710-05df-4370-9d86-514a293a6e2e" providerId="ADAL" clId="{D4B57AB8-9AA6-49E3-B502-D20D87341209}" dt="2024-10-11T02:49:05.931" v="34" actId="1076"/>
          <ac:cxnSpMkLst>
            <pc:docMk/>
            <pc:sldMk cId="285705100" sldId="282"/>
            <ac:cxnSpMk id="50" creationId="{4E60942C-D354-D931-1AB1-447208E17E85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65" creationId="{E2641780-701B-B35E-01D6-720677BA1219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70" creationId="{64907BAA-AD5A-399D-B5FE-53DEC8E54533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71" creationId="{641B57AE-E1A1-59D7-E11D-D6EECA72EF5F}"/>
          </ac:cxnSpMkLst>
        </pc:cxnChg>
        <pc:cxnChg chg="mod">
          <ac:chgData name="Mohan, Man" userId="37104710-05df-4370-9d86-514a293a6e2e" providerId="ADAL" clId="{D4B57AB8-9AA6-49E3-B502-D20D87341209}" dt="2024-10-11T02:45:45.189" v="28" actId="1076"/>
          <ac:cxnSpMkLst>
            <pc:docMk/>
            <pc:sldMk cId="285705100" sldId="282"/>
            <ac:cxnSpMk id="72" creationId="{146A9F88-A897-9A0B-BC3F-54D27DD7AD14}"/>
          </ac:cxnSpMkLst>
        </pc:cxnChg>
      </pc:sldChg>
      <pc:sldChg chg="del">
        <pc:chgData name="Mohan, Man" userId="37104710-05df-4370-9d86-514a293a6e2e" providerId="ADAL" clId="{D4B57AB8-9AA6-49E3-B502-D20D87341209}" dt="2024-10-11T02:41:59.645" v="2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D4B57AB8-9AA6-49E3-B502-D20D87341209}" dt="2024-10-11T02:41:41.254" v="12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D4B57AB8-9AA6-49E3-B502-D20D87341209}" dt="2024-10-11T02:41:58.671" v="19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D4B57AB8-9AA6-49E3-B502-D20D87341209}" dt="2024-10-11T02:41:58.137" v="18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D4B57AB8-9AA6-49E3-B502-D20D87341209}" dt="2024-10-11T02:51:46.643" v="65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D4B57AB8-9AA6-49E3-B502-D20D87341209}" dt="2024-10-11T02:41:56.992" v="17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D4B57AB8-9AA6-49E3-B502-D20D87341209}" dt="2024-10-11T02:41:41.945" v="13" actId="47"/>
        <pc:sldMkLst>
          <pc:docMk/>
          <pc:sldMk cId="4210385526" sldId="505"/>
        </pc:sldMkLst>
      </pc:sldChg>
      <pc:sldChg chg="add del">
        <pc:chgData name="Mohan, Man" userId="37104710-05df-4370-9d86-514a293a6e2e" providerId="ADAL" clId="{D4B57AB8-9AA6-49E3-B502-D20D87341209}" dt="2024-10-11T02:41:54.700" v="16" actId="47"/>
        <pc:sldMkLst>
          <pc:docMk/>
          <pc:sldMk cId="1656193735" sldId="506"/>
        </pc:sldMkLst>
      </pc:sldChg>
    </pc:docChg>
  </pc:docChgLst>
  <pc:docChgLst>
    <pc:chgData name="Mohan, Man" userId="37104710-05df-4370-9d86-514a293a6e2e" providerId="ADAL" clId="{72D6B265-79A2-4EED-B61C-AE9D2D0494BA}"/>
    <pc:docChg chg="delSld">
      <pc:chgData name="Mohan, Man" userId="37104710-05df-4370-9d86-514a293a6e2e" providerId="ADAL" clId="{72D6B265-79A2-4EED-B61C-AE9D2D0494BA}" dt="2024-10-15T20:46:28.675" v="2" actId="47"/>
      <pc:docMkLst>
        <pc:docMk/>
      </pc:docMkLst>
      <pc:sldChg chg="del">
        <pc:chgData name="Mohan, Man" userId="37104710-05df-4370-9d86-514a293a6e2e" providerId="ADAL" clId="{72D6B265-79A2-4EED-B61C-AE9D2D0494BA}" dt="2024-10-15T20:46:27.880" v="0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72D6B265-79A2-4EED-B61C-AE9D2D0494BA}" dt="2024-10-15T20:46:28.261" v="1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72D6B265-79A2-4EED-B61C-AE9D2D0494BA}" dt="2024-10-15T20:46:28.675" v="2" actId="47"/>
        <pc:sldMkLst>
          <pc:docMk/>
          <pc:sldMk cId="2458001602" sldId="28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4">
            <a:extLst>
              <a:ext uri="{FF2B5EF4-FFF2-40B4-BE49-F238E27FC236}">
                <a16:creationId xmlns:a16="http://schemas.microsoft.com/office/drawing/2014/main" id="{EB0844D1-1672-E6B1-19F4-A6756652AA8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2D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FCF07C2-E1D5-1C22-64FD-AC58719FE423}"/>
              </a:ext>
            </a:extLst>
          </p:cNvPr>
          <p:cNvGrpSpPr/>
          <p:nvPr/>
        </p:nvGrpSpPr>
        <p:grpSpPr>
          <a:xfrm>
            <a:off x="7569528" y="1087821"/>
            <a:ext cx="3851402" cy="1850891"/>
            <a:chOff x="777455" y="1307933"/>
            <a:chExt cx="3851402" cy="1850891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FA884B9-0F85-3D11-7EEF-9327721F40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32" t="37717" r="8621" b="30646"/>
            <a:stretch/>
          </p:blipFill>
          <p:spPr>
            <a:xfrm>
              <a:off x="1166565" y="1307933"/>
              <a:ext cx="3462292" cy="1155986"/>
            </a:xfrm>
            <a:prstGeom prst="rect">
              <a:avLst/>
            </a:prstGeom>
          </p:spPr>
        </p:pic>
        <p:sp>
          <p:nvSpPr>
            <p:cNvPr id="22" name="文本框 34">
              <a:extLst>
                <a:ext uri="{FF2B5EF4-FFF2-40B4-BE49-F238E27FC236}">
                  <a16:creationId xmlns:a16="http://schemas.microsoft.com/office/drawing/2014/main" id="{3909F4C2-DA7F-7C69-8D34-6C50601A3DB1}"/>
                </a:ext>
              </a:extLst>
            </p:cNvPr>
            <p:cNvSpPr txBox="1"/>
            <p:nvPr/>
          </p:nvSpPr>
          <p:spPr>
            <a:xfrm>
              <a:off x="2404704" y="2789492"/>
              <a:ext cx="9860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b="1" dirty="0"/>
                <a:t>α-HA</a:t>
              </a:r>
              <a:endParaRPr lang="zh-CN" altLang="en-US" b="1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2A9A6E7-8443-0D3C-0390-8F877D15FBA8}"/>
                </a:ext>
              </a:extLst>
            </p:cNvPr>
            <p:cNvSpPr txBox="1"/>
            <p:nvPr/>
          </p:nvSpPr>
          <p:spPr>
            <a:xfrm>
              <a:off x="857352" y="2124621"/>
              <a:ext cx="4395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0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91CA5BC-9025-E687-F9D4-C040C55BF32A}"/>
                </a:ext>
              </a:extLst>
            </p:cNvPr>
            <p:cNvSpPr txBox="1"/>
            <p:nvPr/>
          </p:nvSpPr>
          <p:spPr>
            <a:xfrm>
              <a:off x="783310" y="184762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3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2A523FA-6E3A-1CA1-248E-3DB2103054DE}"/>
                </a:ext>
              </a:extLst>
            </p:cNvPr>
            <p:cNvSpPr txBox="1"/>
            <p:nvPr/>
          </p:nvSpPr>
          <p:spPr>
            <a:xfrm>
              <a:off x="777455" y="16089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80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A203A09-8601-6874-3B3D-AA76DFDA2D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54" t="49627" r="24573" b="42792"/>
            <a:stretch/>
          </p:blipFill>
          <p:spPr>
            <a:xfrm>
              <a:off x="1499033" y="2488755"/>
              <a:ext cx="2414847" cy="275900"/>
            </a:xfrm>
            <a:prstGeom prst="rect">
              <a:avLst/>
            </a:prstGeom>
          </p:spPr>
        </p:pic>
      </p:grpSp>
      <p:pic>
        <p:nvPicPr>
          <p:cNvPr id="20" name="Picture 19">
            <a:extLst>
              <a:ext uri="{FF2B5EF4-FFF2-40B4-BE49-F238E27FC236}">
                <a16:creationId xmlns:a16="http://schemas.microsoft.com/office/drawing/2014/main" id="{3F2D8EEE-B5D1-9AF8-9D93-D631FBD1493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09" t="34589" r="11993" b="31518"/>
          <a:stretch/>
        </p:blipFill>
        <p:spPr>
          <a:xfrm>
            <a:off x="7850058" y="3964308"/>
            <a:ext cx="3027285" cy="113634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660283C-AD0E-B21E-B5DB-BDA4D0114272}"/>
              </a:ext>
            </a:extLst>
          </p:cNvPr>
          <p:cNvSpPr txBox="1"/>
          <p:nvPr/>
        </p:nvSpPr>
        <p:spPr>
          <a:xfrm>
            <a:off x="10832395" y="4356837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29" name="文本框 34">
            <a:extLst>
              <a:ext uri="{FF2B5EF4-FFF2-40B4-BE49-F238E27FC236}">
                <a16:creationId xmlns:a16="http://schemas.microsoft.com/office/drawing/2014/main" id="{9F3BAD79-E319-EE02-DB52-BE09DE9E2929}"/>
              </a:ext>
            </a:extLst>
          </p:cNvPr>
          <p:cNvSpPr txBox="1"/>
          <p:nvPr/>
        </p:nvSpPr>
        <p:spPr>
          <a:xfrm>
            <a:off x="9218647" y="5555627"/>
            <a:ext cx="9860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/>
              <a:t>α-Actin</a:t>
            </a:r>
            <a:endParaRPr lang="zh-CN" altLang="en-US" b="1" dirty="0"/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73D35E39-49AF-CA5C-3165-F63BF7EF202B}"/>
              </a:ext>
            </a:extLst>
          </p:cNvPr>
          <p:cNvCxnSpPr/>
          <p:nvPr/>
        </p:nvCxnSpPr>
        <p:spPr>
          <a:xfrm>
            <a:off x="9422186" y="4638170"/>
            <a:ext cx="5549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ED0E1AF0-0669-ED61-EBCE-9D1B972D70DE}"/>
              </a:ext>
            </a:extLst>
          </p:cNvPr>
          <p:cNvCxnSpPr>
            <a:cxnSpLocks/>
          </p:cNvCxnSpPr>
          <p:nvPr/>
        </p:nvCxnSpPr>
        <p:spPr>
          <a:xfrm flipV="1">
            <a:off x="9695317" y="4723777"/>
            <a:ext cx="0" cy="4727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6C3FA539-9DC2-E21F-32E9-A95A752AFDA6}"/>
              </a:ext>
            </a:extLst>
          </p:cNvPr>
          <p:cNvSpPr txBox="1"/>
          <p:nvPr/>
        </p:nvSpPr>
        <p:spPr>
          <a:xfrm>
            <a:off x="10832395" y="3848527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228CED2-8ACA-EAC5-4CCF-DAFFEBF955E7}"/>
              </a:ext>
            </a:extLst>
          </p:cNvPr>
          <p:cNvSpPr txBox="1"/>
          <p:nvPr/>
        </p:nvSpPr>
        <p:spPr>
          <a:xfrm>
            <a:off x="10832395" y="4079838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8ACC960-5FD5-F5CF-83C9-015EA17F81C7}"/>
              </a:ext>
            </a:extLst>
          </p:cNvPr>
          <p:cNvSpPr txBox="1"/>
          <p:nvPr/>
        </p:nvSpPr>
        <p:spPr>
          <a:xfrm>
            <a:off x="10832395" y="4657816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5</a:t>
            </a:r>
          </a:p>
        </p:txBody>
      </p:sp>
      <p:pic>
        <p:nvPicPr>
          <p:cNvPr id="74" name="图片 11">
            <a:extLst>
              <a:ext uri="{FF2B5EF4-FFF2-40B4-BE49-F238E27FC236}">
                <a16:creationId xmlns:a16="http://schemas.microsoft.com/office/drawing/2014/main" id="{BAAA6E0C-DE98-1CFD-5373-D62F2B35AA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66023" y="5267551"/>
            <a:ext cx="647521" cy="1881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C62905AC-386B-E184-4150-5F72AF482BBC}"/>
              </a:ext>
            </a:extLst>
          </p:cNvPr>
          <p:cNvGrpSpPr/>
          <p:nvPr/>
        </p:nvGrpSpPr>
        <p:grpSpPr>
          <a:xfrm>
            <a:off x="1453950" y="3802142"/>
            <a:ext cx="5392634" cy="2338692"/>
            <a:chOff x="3010365" y="-100799"/>
            <a:chExt cx="5392634" cy="2338692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331B232-A3B9-093B-BE00-F6CCE45E7325}"/>
                </a:ext>
              </a:extLst>
            </p:cNvPr>
            <p:cNvGrpSpPr/>
            <p:nvPr/>
          </p:nvGrpSpPr>
          <p:grpSpPr>
            <a:xfrm>
              <a:off x="3010365" y="415079"/>
              <a:ext cx="5392634" cy="1822814"/>
              <a:chOff x="6384271" y="1213214"/>
              <a:chExt cx="5392634" cy="1822814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3EC8F080-BACC-60DA-B616-7CB6FFA5AD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698" t="27692" r="18071" b="22264"/>
              <a:stretch/>
            </p:blipFill>
            <p:spPr>
              <a:xfrm>
                <a:off x="6384271" y="1213214"/>
                <a:ext cx="2902999" cy="1822814"/>
              </a:xfrm>
              <a:prstGeom prst="rect">
                <a:avLst/>
              </a:prstGeom>
            </p:spPr>
          </p:pic>
          <p:sp>
            <p:nvSpPr>
              <p:cNvPr id="9" name="文本框 34">
                <a:extLst>
                  <a:ext uri="{FF2B5EF4-FFF2-40B4-BE49-F238E27FC236}">
                    <a16:creationId xmlns:a16="http://schemas.microsoft.com/office/drawing/2014/main" id="{EA1AC91D-6689-6610-EB40-DF93AF40A1A6}"/>
                  </a:ext>
                </a:extLst>
              </p:cNvPr>
              <p:cNvSpPr txBox="1"/>
              <p:nvPr/>
            </p:nvSpPr>
            <p:spPr>
              <a:xfrm>
                <a:off x="9454480" y="1223920"/>
                <a:ext cx="2188822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b="1" dirty="0"/>
                  <a:t>α-Flag (DYRK1A)</a:t>
                </a:r>
                <a:endParaRPr lang="zh-CN" altLang="en-US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67F67BD-2C9A-97E3-CE77-A07EF761662B}"/>
                  </a:ext>
                </a:extLst>
              </p:cNvPr>
              <p:cNvSpPr txBox="1"/>
              <p:nvPr/>
            </p:nvSpPr>
            <p:spPr>
              <a:xfrm>
                <a:off x="9206378" y="1454752"/>
                <a:ext cx="4103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75</a:t>
                </a:r>
              </a:p>
            </p:txBody>
          </p:sp>
          <p:sp>
            <p:nvSpPr>
              <p:cNvPr id="11" name="文本框 34">
                <a:extLst>
                  <a:ext uri="{FF2B5EF4-FFF2-40B4-BE49-F238E27FC236}">
                    <a16:creationId xmlns:a16="http://schemas.microsoft.com/office/drawing/2014/main" id="{A046E86D-676E-DD76-84BD-44958E7337FF}"/>
                  </a:ext>
                </a:extLst>
              </p:cNvPr>
              <p:cNvSpPr txBox="1"/>
              <p:nvPr/>
            </p:nvSpPr>
            <p:spPr>
              <a:xfrm>
                <a:off x="9487031" y="2375977"/>
                <a:ext cx="2289874" cy="64633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b="1" dirty="0"/>
                  <a:t>α-Flag (DYRK1A Core)</a:t>
                </a:r>
                <a:endParaRPr lang="zh-CN" altLang="en-US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A27DD53-EC9C-6CA9-496E-D84A3A5DED21}"/>
                  </a:ext>
                </a:extLst>
              </p:cNvPr>
              <p:cNvSpPr txBox="1"/>
              <p:nvPr/>
            </p:nvSpPr>
            <p:spPr>
              <a:xfrm>
                <a:off x="9206378" y="1758524"/>
                <a:ext cx="4103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63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0BCCEDB-3B85-FB6D-1259-764AD0250FC6}"/>
                  </a:ext>
                </a:extLst>
              </p:cNvPr>
              <p:cNvSpPr txBox="1"/>
              <p:nvPr/>
            </p:nvSpPr>
            <p:spPr>
              <a:xfrm>
                <a:off x="9206378" y="2085077"/>
                <a:ext cx="4103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8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39B6BAD-3F84-4A49-16F0-FB8A1D826F9E}"/>
                  </a:ext>
                </a:extLst>
              </p:cNvPr>
              <p:cNvSpPr txBox="1"/>
              <p:nvPr/>
            </p:nvSpPr>
            <p:spPr>
              <a:xfrm>
                <a:off x="9206378" y="1229690"/>
                <a:ext cx="6063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0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B015359-C663-2FE1-2F15-8F8DEE816261}"/>
                  </a:ext>
                </a:extLst>
              </p:cNvPr>
              <p:cNvSpPr txBox="1"/>
              <p:nvPr/>
            </p:nvSpPr>
            <p:spPr>
              <a:xfrm>
                <a:off x="9206378" y="2389838"/>
                <a:ext cx="4103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35</a:t>
                </a:r>
              </a:p>
            </p:txBody>
          </p: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4FC24FE0-AA5D-D273-98D3-EF46863D24F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492830" y="1824524"/>
                <a:ext cx="579762" cy="9311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EB0813F-470F-7BED-7208-2F8F0EB61B9F}"/>
                </a:ext>
              </a:extLst>
            </p:cNvPr>
            <p:cNvSpPr txBox="1"/>
            <p:nvPr/>
          </p:nvSpPr>
          <p:spPr>
            <a:xfrm>
              <a:off x="6698686" y="822659"/>
              <a:ext cx="170431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embrane was</a:t>
              </a:r>
            </a:p>
            <a:p>
              <a:r>
                <a:rPr lang="en-US" dirty="0"/>
                <a:t> cut here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98200D3-E3A4-C678-2F35-4DC7C2C878E5}"/>
                </a:ext>
              </a:extLst>
            </p:cNvPr>
            <p:cNvSpPr txBox="1"/>
            <p:nvPr/>
          </p:nvSpPr>
          <p:spPr>
            <a:xfrm>
              <a:off x="3422045" y="-100799"/>
              <a:ext cx="2654894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/>
                <a:t>Sample loading direction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1AD94848-567E-6FFE-1306-846DEF0E305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816710" y="307035"/>
              <a:ext cx="1327281" cy="696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8835E2A-99AD-71C4-36A7-21DE87BF51C6}"/>
              </a:ext>
            </a:extLst>
          </p:cNvPr>
          <p:cNvGrpSpPr/>
          <p:nvPr/>
        </p:nvGrpSpPr>
        <p:grpSpPr>
          <a:xfrm>
            <a:off x="949430" y="314691"/>
            <a:ext cx="4605853" cy="2821399"/>
            <a:chOff x="5494014" y="2805378"/>
            <a:chExt cx="4605853" cy="2821399"/>
          </a:xfrm>
        </p:grpSpPr>
        <p:pic>
          <p:nvPicPr>
            <p:cNvPr id="19" name="图片 3">
              <a:extLst>
                <a:ext uri="{FF2B5EF4-FFF2-40B4-BE49-F238E27FC236}">
                  <a16:creationId xmlns:a16="http://schemas.microsoft.com/office/drawing/2014/main" id="{61074FAC-B360-EEBC-DF46-3BF9E4A7F4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692" r="12120" b="81556"/>
            <a:stretch/>
          </p:blipFill>
          <p:spPr>
            <a:xfrm flipH="1">
              <a:off x="7276546" y="4685579"/>
              <a:ext cx="2743200" cy="30637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1" name="图片 3">
              <a:extLst>
                <a:ext uri="{FF2B5EF4-FFF2-40B4-BE49-F238E27FC236}">
                  <a16:creationId xmlns:a16="http://schemas.microsoft.com/office/drawing/2014/main" id="{B1FE1E03-00E9-F902-EB1E-489E9C87E4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692" t="74541" r="12120" b="8784"/>
            <a:stretch/>
          </p:blipFill>
          <p:spPr>
            <a:xfrm flipH="1">
              <a:off x="7276546" y="5049563"/>
              <a:ext cx="2743200" cy="2769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5" name="TextBox 18">
              <a:extLst>
                <a:ext uri="{FF2B5EF4-FFF2-40B4-BE49-F238E27FC236}">
                  <a16:creationId xmlns:a16="http://schemas.microsoft.com/office/drawing/2014/main" id="{363A6695-EF85-D109-394C-A459B383F3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27169" y="2826586"/>
              <a:ext cx="26802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en-US" sz="1400" b="1" dirty="0"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6" name="文本框 4">
              <a:extLst>
                <a:ext uri="{FF2B5EF4-FFF2-40B4-BE49-F238E27FC236}">
                  <a16:creationId xmlns:a16="http://schemas.microsoft.com/office/drawing/2014/main" id="{78863437-56C6-6438-7672-9BF1844C1EA2}"/>
                </a:ext>
              </a:extLst>
            </p:cNvPr>
            <p:cNvSpPr txBox="1"/>
            <p:nvPr/>
          </p:nvSpPr>
          <p:spPr>
            <a:xfrm>
              <a:off x="5916105" y="4682702"/>
              <a:ext cx="1377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b="0" dirty="0"/>
                <a:t>α-Flag (DYRK1A)</a:t>
              </a:r>
              <a:endParaRPr lang="zh-CN" altLang="en-US" b="0" dirty="0"/>
            </a:p>
          </p:txBody>
        </p:sp>
        <p:pic>
          <p:nvPicPr>
            <p:cNvPr id="28" name="图片 9">
              <a:extLst>
                <a:ext uri="{FF2B5EF4-FFF2-40B4-BE49-F238E27FC236}">
                  <a16:creationId xmlns:a16="http://schemas.microsoft.com/office/drawing/2014/main" id="{92C3F3CC-55A4-EFF9-A4F3-8C768DF91D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86" t="50361" r="25974" b="43601"/>
            <a:stretch/>
          </p:blipFill>
          <p:spPr>
            <a:xfrm flipH="1">
              <a:off x="7277361" y="4328726"/>
              <a:ext cx="2743200" cy="29966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30" name="文本框 10">
              <a:extLst>
                <a:ext uri="{FF2B5EF4-FFF2-40B4-BE49-F238E27FC236}">
                  <a16:creationId xmlns:a16="http://schemas.microsoft.com/office/drawing/2014/main" id="{2A56398A-29F3-D46A-4974-368CDF59B204}"/>
                </a:ext>
              </a:extLst>
            </p:cNvPr>
            <p:cNvSpPr txBox="1"/>
            <p:nvPr/>
          </p:nvSpPr>
          <p:spPr>
            <a:xfrm>
              <a:off x="5916105" y="4356098"/>
              <a:ext cx="1377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α-HA (TSC1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图片 11">
              <a:extLst>
                <a:ext uri="{FF2B5EF4-FFF2-40B4-BE49-F238E27FC236}">
                  <a16:creationId xmlns:a16="http://schemas.microsoft.com/office/drawing/2014/main" id="{C20E01DA-AA2E-8755-17EF-6E617DA561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277361" y="5387611"/>
              <a:ext cx="822960" cy="23916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33" name="文本框 12">
              <a:extLst>
                <a:ext uri="{FF2B5EF4-FFF2-40B4-BE49-F238E27FC236}">
                  <a16:creationId xmlns:a16="http://schemas.microsoft.com/office/drawing/2014/main" id="{0934D3BB-4DCD-BB34-114F-CD4F061D5D66}"/>
                </a:ext>
              </a:extLst>
            </p:cNvPr>
            <p:cNvSpPr txBox="1"/>
            <p:nvPr/>
          </p:nvSpPr>
          <p:spPr>
            <a:xfrm>
              <a:off x="5916105" y="5346795"/>
              <a:ext cx="1377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b="0" dirty="0"/>
                <a:t>α-Actin</a:t>
              </a:r>
              <a:endParaRPr lang="zh-CN" altLang="en-US" b="0" dirty="0"/>
            </a:p>
          </p:txBody>
        </p:sp>
        <p:sp>
          <p:nvSpPr>
            <p:cNvPr id="34" name="文本框 28">
              <a:extLst>
                <a:ext uri="{FF2B5EF4-FFF2-40B4-BE49-F238E27FC236}">
                  <a16:creationId xmlns:a16="http://schemas.microsoft.com/office/drawing/2014/main" id="{CC42CDED-0D3E-17CC-8B25-65BAF457EC2A}"/>
                </a:ext>
              </a:extLst>
            </p:cNvPr>
            <p:cNvSpPr txBox="1"/>
            <p:nvPr/>
          </p:nvSpPr>
          <p:spPr>
            <a:xfrm>
              <a:off x="7557749" y="2918563"/>
              <a:ext cx="7346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29">
              <a:extLst>
                <a:ext uri="{FF2B5EF4-FFF2-40B4-BE49-F238E27FC236}">
                  <a16:creationId xmlns:a16="http://schemas.microsoft.com/office/drawing/2014/main" id="{A5D02F92-B1B9-B7D1-AF24-CF961971B4BB}"/>
                </a:ext>
              </a:extLst>
            </p:cNvPr>
            <p:cNvSpPr txBox="1"/>
            <p:nvPr/>
          </p:nvSpPr>
          <p:spPr>
            <a:xfrm>
              <a:off x="8211411" y="2805378"/>
              <a:ext cx="9668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tein A</a:t>
              </a:r>
            </a:p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eads-I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2">
              <a:extLst>
                <a:ext uri="{FF2B5EF4-FFF2-40B4-BE49-F238E27FC236}">
                  <a16:creationId xmlns:a16="http://schemas.microsoft.com/office/drawing/2014/main" id="{A22B2A63-54B4-62D6-6D0F-245EE9C1918E}"/>
                </a:ext>
              </a:extLst>
            </p:cNvPr>
            <p:cNvSpPr txBox="1"/>
            <p:nvPr/>
          </p:nvSpPr>
          <p:spPr>
            <a:xfrm>
              <a:off x="9085931" y="2805378"/>
              <a:ext cx="96688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Flag-</a:t>
              </a:r>
            </a:p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eads-I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接连接符 38">
              <a:extLst>
                <a:ext uri="{FF2B5EF4-FFF2-40B4-BE49-F238E27FC236}">
                  <a16:creationId xmlns:a16="http://schemas.microsoft.com/office/drawing/2014/main" id="{125E3F26-70B3-D05A-F3EB-0223DC48CD09}"/>
                </a:ext>
              </a:extLst>
            </p:cNvPr>
            <p:cNvCxnSpPr>
              <a:cxnSpLocks/>
            </p:cNvCxnSpPr>
            <p:nvPr/>
          </p:nvCxnSpPr>
          <p:spPr>
            <a:xfrm>
              <a:off x="9156465" y="3294687"/>
              <a:ext cx="7952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94">
              <a:extLst>
                <a:ext uri="{FF2B5EF4-FFF2-40B4-BE49-F238E27FC236}">
                  <a16:creationId xmlns:a16="http://schemas.microsoft.com/office/drawing/2014/main" id="{FD868CD1-0826-92CE-C8D7-5152AB36E4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99843" y="4100201"/>
              <a:ext cx="36746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en-US" sz="1200" b="1" dirty="0">
                  <a:cs typeface="Arial" panose="020B0604020202020204" pitchFamily="34" charset="0"/>
                </a:rPr>
                <a:t>HA3-TSC1   +     +      +     +     +     +     +     +     + </a:t>
              </a:r>
            </a:p>
          </p:txBody>
        </p:sp>
        <p:sp>
          <p:nvSpPr>
            <p:cNvPr id="41" name="TextBox 94">
              <a:extLst>
                <a:ext uri="{FF2B5EF4-FFF2-40B4-BE49-F238E27FC236}">
                  <a16:creationId xmlns:a16="http://schemas.microsoft.com/office/drawing/2014/main" id="{0D104BA0-BC11-1745-6F0D-713A5232B5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75628" y="3576582"/>
              <a:ext cx="389884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en-US" sz="1200" b="1" dirty="0">
                  <a:cs typeface="Arial" panose="020B0604020202020204" pitchFamily="34" charset="0"/>
                </a:rPr>
                <a:t>Flag-DYRK1A   -     +       -      -     +      -     -     +     - </a:t>
              </a:r>
            </a:p>
          </p:txBody>
        </p:sp>
        <p:sp>
          <p:nvSpPr>
            <p:cNvPr id="47" name="TextBox 94">
              <a:extLst>
                <a:ext uri="{FF2B5EF4-FFF2-40B4-BE49-F238E27FC236}">
                  <a16:creationId xmlns:a16="http://schemas.microsoft.com/office/drawing/2014/main" id="{5CC12EA6-FAB8-570E-4041-354909EBA6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73281" y="3852366"/>
              <a:ext cx="422658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en-US" sz="1200" b="1" dirty="0">
                  <a:cs typeface="Arial" panose="020B0604020202020204" pitchFamily="34" charset="0"/>
                </a:rPr>
                <a:t>Flag-Kinase Dom.   -     -       +     -      -      +     -      -     + </a:t>
              </a:r>
            </a:p>
          </p:txBody>
        </p:sp>
        <p:sp>
          <p:nvSpPr>
            <p:cNvPr id="48" name="TextBox 94">
              <a:extLst>
                <a:ext uri="{FF2B5EF4-FFF2-40B4-BE49-F238E27FC236}">
                  <a16:creationId xmlns:a16="http://schemas.microsoft.com/office/drawing/2014/main" id="{77C8E70C-8C8C-43C9-8AC9-541B36BCA8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34164" y="3334468"/>
              <a:ext cx="368639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en-US" sz="1200" b="1" dirty="0">
                  <a:cs typeface="Arial" panose="020B0604020202020204" pitchFamily="34" charset="0"/>
                </a:rPr>
                <a:t>Flag-Vector   +    -        -     +     -      -     +     -      - </a:t>
              </a:r>
            </a:p>
          </p:txBody>
        </p:sp>
        <p:cxnSp>
          <p:nvCxnSpPr>
            <p:cNvPr id="49" name="直接连接符 38">
              <a:extLst>
                <a:ext uri="{FF2B5EF4-FFF2-40B4-BE49-F238E27FC236}">
                  <a16:creationId xmlns:a16="http://schemas.microsoft.com/office/drawing/2014/main" id="{B001C3F8-3AF9-4101-85D5-FF6108143231}"/>
                </a:ext>
              </a:extLst>
            </p:cNvPr>
            <p:cNvCxnSpPr>
              <a:cxnSpLocks/>
            </p:cNvCxnSpPr>
            <p:nvPr/>
          </p:nvCxnSpPr>
          <p:spPr>
            <a:xfrm>
              <a:off x="8273706" y="3294687"/>
              <a:ext cx="7952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接连接符 38">
              <a:extLst>
                <a:ext uri="{FF2B5EF4-FFF2-40B4-BE49-F238E27FC236}">
                  <a16:creationId xmlns:a16="http://schemas.microsoft.com/office/drawing/2014/main" id="{4E60942C-D354-D931-1AB1-447208E17E85}"/>
                </a:ext>
              </a:extLst>
            </p:cNvPr>
            <p:cNvCxnSpPr>
              <a:cxnSpLocks/>
            </p:cNvCxnSpPr>
            <p:nvPr/>
          </p:nvCxnSpPr>
          <p:spPr>
            <a:xfrm>
              <a:off x="7390947" y="3294687"/>
              <a:ext cx="7952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4">
              <a:extLst>
                <a:ext uri="{FF2B5EF4-FFF2-40B4-BE49-F238E27FC236}">
                  <a16:creationId xmlns:a16="http://schemas.microsoft.com/office/drawing/2014/main" id="{007FFAC5-1ADF-698F-AC26-3FD88668AFC9}"/>
                </a:ext>
              </a:extLst>
            </p:cNvPr>
            <p:cNvSpPr txBox="1"/>
            <p:nvPr/>
          </p:nvSpPr>
          <p:spPr>
            <a:xfrm>
              <a:off x="5494014" y="5058197"/>
              <a:ext cx="17998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r"/>
              <a:r>
                <a:rPr lang="en-US" altLang="zh-CN" b="0" dirty="0"/>
                <a:t>α-Flag (DYRK1A-Core)</a:t>
              </a:r>
              <a:endParaRPr lang="zh-CN" altLang="en-US" b="0" dirty="0"/>
            </a:p>
          </p:txBody>
        </p:sp>
      </p:grpSp>
    </p:spTree>
    <p:extLst>
      <p:ext uri="{BB962C8B-B14F-4D97-AF65-F5344CB8AC3E}">
        <p14:creationId xmlns:p14="http://schemas.microsoft.com/office/powerpoint/2010/main" val="285705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2</TotalTime>
  <Words>97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46:35Z</dcterms:modified>
</cp:coreProperties>
</file>